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942" y="-29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1000" y="457200"/>
            <a:ext cx="2209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4800" y="4186535"/>
            <a:ext cx="6096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creased apoptotic activity in xenograft tumors (day 35) treated with miR-410 relative to miR-NC, assessed by caspase 3/7 ELISA assay (Promega)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75" y="1143000"/>
            <a:ext cx="4286250" cy="289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91878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iopoulos, Dimitrios</dc:creator>
  <cp:lastModifiedBy>Real, Francis Frank</cp:lastModifiedBy>
  <cp:revision>7</cp:revision>
  <dcterms:created xsi:type="dcterms:W3CDTF">2006-08-16T00:00:00Z</dcterms:created>
  <dcterms:modified xsi:type="dcterms:W3CDTF">2016-06-01T23:37:03Z</dcterms:modified>
</cp:coreProperties>
</file>